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73"/>
    <p:restoredTop sz="94737"/>
  </p:normalViewPr>
  <p:slideViewPr>
    <p:cSldViewPr>
      <p:cViewPr varScale="1">
        <p:scale>
          <a:sx n="82" d="100"/>
          <a:sy n="82" d="100"/>
        </p:scale>
        <p:origin x="880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FDA5-2AC5-41C6-BBA7-6D4142FA7518}" type="datetimeFigureOut">
              <a:rPr lang="en-US" smtClean="0"/>
              <a:t>4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B3C2-6378-47D9-9AA0-C4060FCAECC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FDA5-2AC5-41C6-BBA7-6D4142FA7518}" type="datetimeFigureOut">
              <a:rPr lang="en-US" smtClean="0"/>
              <a:t>4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B3C2-6378-47D9-9AA0-C4060FCAECC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FDA5-2AC5-41C6-BBA7-6D4142FA7518}" type="datetimeFigureOut">
              <a:rPr lang="en-US" smtClean="0"/>
              <a:t>4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B3C2-6378-47D9-9AA0-C4060FCAECC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FDA5-2AC5-41C6-BBA7-6D4142FA7518}" type="datetimeFigureOut">
              <a:rPr lang="en-US" smtClean="0"/>
              <a:t>4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B3C2-6378-47D9-9AA0-C4060FCAECC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FDA5-2AC5-41C6-BBA7-6D4142FA7518}" type="datetimeFigureOut">
              <a:rPr lang="en-US" smtClean="0"/>
              <a:t>4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B3C2-6378-47D9-9AA0-C4060FCAECC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FDA5-2AC5-41C6-BBA7-6D4142FA7518}" type="datetimeFigureOut">
              <a:rPr lang="en-US" smtClean="0"/>
              <a:t>4/2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B3C2-6378-47D9-9AA0-C4060FCAECC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FDA5-2AC5-41C6-BBA7-6D4142FA7518}" type="datetimeFigureOut">
              <a:rPr lang="en-US" smtClean="0"/>
              <a:t>4/20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B3C2-6378-47D9-9AA0-C4060FCAECC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FDA5-2AC5-41C6-BBA7-6D4142FA7518}" type="datetimeFigureOut">
              <a:rPr lang="en-US" smtClean="0"/>
              <a:t>4/20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B3C2-6378-47D9-9AA0-C4060FCAECC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FDA5-2AC5-41C6-BBA7-6D4142FA7518}" type="datetimeFigureOut">
              <a:rPr lang="en-US" smtClean="0"/>
              <a:t>4/20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B3C2-6378-47D9-9AA0-C4060FCAECC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FDA5-2AC5-41C6-BBA7-6D4142FA7518}" type="datetimeFigureOut">
              <a:rPr lang="en-US" smtClean="0"/>
              <a:t>4/2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B3C2-6378-47D9-9AA0-C4060FCAECC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3FDA5-2AC5-41C6-BBA7-6D4142FA7518}" type="datetimeFigureOut">
              <a:rPr lang="en-US" smtClean="0"/>
              <a:t>4/2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B3C2-6378-47D9-9AA0-C4060FCAECC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B3FDA5-2AC5-41C6-BBA7-6D4142FA7518}" type="datetimeFigureOut">
              <a:rPr lang="en-US" smtClean="0"/>
              <a:t>4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41B3C2-6378-47D9-9AA0-C4060FCAECC2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52600" y="5638800"/>
            <a:ext cx="327660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52400" y="1752600"/>
            <a:ext cx="8801661" cy="350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2E3B1D0-3174-EF42-A8F3-12CC04248176}"/>
              </a:ext>
            </a:extLst>
          </p:cNvPr>
          <p:cNvSpPr txBox="1"/>
          <p:nvPr/>
        </p:nvSpPr>
        <p:spPr>
          <a:xfrm>
            <a:off x="5746467" y="152400"/>
            <a:ext cx="3397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hen et al., Supplemental Figure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7DA5AEA-8F19-C04A-A6CD-A235888588E2}"/>
              </a:ext>
            </a:extLst>
          </p:cNvPr>
          <p:cNvSpPr txBox="1"/>
          <p:nvPr/>
        </p:nvSpPr>
        <p:spPr>
          <a:xfrm>
            <a:off x="6272348" y="5454134"/>
            <a:ext cx="2345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: short arm of vecto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51268BE-02B4-4748-96D1-874249F6CFED}"/>
              </a:ext>
            </a:extLst>
          </p:cNvPr>
          <p:cNvSpPr txBox="1"/>
          <p:nvPr/>
        </p:nvSpPr>
        <p:spPr>
          <a:xfrm>
            <a:off x="6272348" y="6119336"/>
            <a:ext cx="23073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A:  long arm of vecto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CF1D172-2A17-F840-89A0-00524B7FD688}"/>
              </a:ext>
            </a:extLst>
          </p:cNvPr>
          <p:cNvSpPr txBox="1"/>
          <p:nvPr/>
        </p:nvSpPr>
        <p:spPr>
          <a:xfrm>
            <a:off x="6280051" y="5792691"/>
            <a:ext cx="2650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:  middle arm of vector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87</TotalTime>
  <Words>25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echen</dc:creator>
  <cp:lastModifiedBy>Dapeng Zhou</cp:lastModifiedBy>
  <cp:revision>5</cp:revision>
  <dcterms:created xsi:type="dcterms:W3CDTF">2013-03-25T19:56:56Z</dcterms:created>
  <dcterms:modified xsi:type="dcterms:W3CDTF">2019-04-20T05:55:37Z</dcterms:modified>
</cp:coreProperties>
</file>